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4.jpeg" ContentType="image/jpeg"/>
  <Override PartName="/ppt/media/image26.jpeg" ContentType="image/jpeg"/>
  <Override PartName="/ppt/media/image5.jpeg" ContentType="image/jpeg"/>
  <Override PartName="/ppt/media/image13.jpeg" ContentType="image/jpeg"/>
  <Override PartName="/ppt/media/image8.jpeg" ContentType="image/jpeg"/>
  <Override PartName="/ppt/media/image29.jpeg" ContentType="image/jpeg"/>
  <Override PartName="/ppt/media/image10.jpeg" ContentType="image/jpeg"/>
  <Override PartName="/ppt/media/image27.jpeg" ContentType="image/jpeg"/>
  <Override PartName="/ppt/media/image6.jpeg" ContentType="image/jpeg"/>
  <Override PartName="/ppt/media/image11.jpeg" ContentType="image/jpeg"/>
  <Override PartName="/ppt/media/image9.jpeg" ContentType="image/jpeg"/>
  <Override PartName="/ppt/media/image28.jpeg" ContentType="image/jpeg"/>
  <Override PartName="/ppt/media/image7.jpeg" ContentType="image/jpeg"/>
  <Override PartName="/ppt/media/image30.jpeg" ContentType="image/jpeg"/>
  <Override PartName="/ppt/media/image12.jpeg" ContentType="image/jpeg"/>
  <Override PartName="/ppt/media/image4.png" ContentType="image/png"/>
  <Override PartName="/ppt/media/image3.png" ContentType="image/png"/>
  <Override PartName="/ppt/media/image17.jpeg" ContentType="image/jpeg"/>
  <Override PartName="/ppt/media/image2.png" ContentType="image/png"/>
  <Override PartName="/ppt/media/image25.jpeg" ContentType="image/jpeg"/>
  <Override PartName="/ppt/media/image1.png" ContentType="image/png"/>
  <Override PartName="/ppt/media/image14.jpeg" ContentType="image/jpeg"/>
  <Override PartName="/ppt/media/image15.jpeg" ContentType="image/jpeg"/>
  <Override PartName="/ppt/media/image16.jpeg" ContentType="image/jpeg"/>
  <Override PartName="/ppt/media/image18.jpeg" ContentType="image/jpeg"/>
  <Override PartName="/ppt/media/image19.jpeg" ContentType="image/jpeg"/>
  <Override PartName="/ppt/media/image20.jpeg" ContentType="image/jpeg"/>
  <Override PartName="/ppt/media/image21.jpeg" ContentType="image/jpeg"/>
  <Override PartName="/ppt/media/image22.jpeg" ContentType="image/jpeg"/>
  <Override PartName="/ppt/media/image2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349EC-5D20-4A2B-972F-EBCEEBD2D7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CA023-714F-472B-B165-DBBA5EB870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0AB2F-F536-43C8-AB47-E2B5E5FFEE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F2A10-A94A-4812-A6C7-BD89260466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FBF15-C32E-4394-98A2-90A2C83731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010DC-870E-4875-9DD8-AD656BFAD4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E24B1-3B97-4EC3-B0E6-9A8E3ACB02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C04C9-B2C4-4875-A2AD-4CB5DD9D08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72AEB-DBF2-4971-83E2-8B47FB5537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89E36B-6829-43D8-A725-B540B33AD2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4CAE2-D824-4F33-A778-63D056C1D0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015BA-1B0F-47A2-B8AC-C45C92A601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8FDEEE-0215-40EF-AFF5-2051562E821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image" Target="../media/image29.jpeg"/><Relationship Id="rId30" Type="http://schemas.openxmlformats.org/officeDocument/2006/relationships/image" Target="../media/image30.jpeg"/><Relationship Id="rId3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7680" y="3869640"/>
            <a:ext cx="6566040" cy="1302480"/>
            <a:chOff x="247680" y="3869640"/>
            <a:chExt cx="6566040" cy="1302480"/>
          </a:xfrm>
        </p:grpSpPr>
        <p:sp>
          <p:nvSpPr>
            <p:cNvPr id="42" name=""/>
            <p:cNvSpPr/>
            <p:nvPr/>
          </p:nvSpPr>
          <p:spPr>
            <a:xfrm>
              <a:off x="747720" y="4680000"/>
              <a:ext cx="108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747720" y="4859280"/>
              <a:ext cx="108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1">
              <a:lum bright="-6000"/>
            </a:blip>
            <a:stretch/>
          </p:blipFill>
          <p:spPr>
            <a:xfrm>
              <a:off x="3451320" y="4937040"/>
              <a:ext cx="2590560" cy="16200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5" name="" descr=""/>
            <p:cNvPicPr/>
            <p:nvPr/>
          </p:nvPicPr>
          <p:blipFill>
            <a:blip r:embed="rId2">
              <a:lum bright="-6000"/>
            </a:blip>
            <a:srcRect l="1338" t="-1038" r="892" b="1153"/>
            <a:stretch/>
          </p:blipFill>
          <p:spPr>
            <a:xfrm>
              <a:off x="841320" y="4937040"/>
              <a:ext cx="2590920" cy="16200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6" name="" descr=""/>
            <p:cNvPicPr/>
            <p:nvPr/>
          </p:nvPicPr>
          <p:blipFill>
            <a:blip r:embed="rId3"/>
            <a:stretch/>
          </p:blipFill>
          <p:spPr>
            <a:xfrm>
              <a:off x="841320" y="4557600"/>
              <a:ext cx="2590920" cy="36036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47" name="" descr=""/>
            <p:cNvPicPr/>
            <p:nvPr/>
          </p:nvPicPr>
          <p:blipFill>
            <a:blip r:embed="rId4"/>
            <a:stretch/>
          </p:blipFill>
          <p:spPr>
            <a:xfrm>
              <a:off x="3451320" y="4557600"/>
              <a:ext cx="2590560" cy="36036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48" name=""/>
            <p:cNvSpPr/>
            <p:nvPr/>
          </p:nvSpPr>
          <p:spPr>
            <a:xfrm rot="19234200">
              <a:off x="1588320" y="4255200"/>
              <a:ext cx="533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9234200">
              <a:off x="2135880" y="4264920"/>
              <a:ext cx="503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7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9234200">
              <a:off x="2661480" y="4282200"/>
              <a:ext cx="446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9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9234200">
              <a:off x="3159720" y="4271760"/>
              <a:ext cx="482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9234200">
              <a:off x="1050120" y="4222080"/>
              <a:ext cx="639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885960" y="4173480"/>
              <a:ext cx="2519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470400" y="4173480"/>
              <a:ext cx="2519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19280" y="3936960"/>
              <a:ext cx="281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gro-infiltrated leav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367080" y="3936960"/>
              <a:ext cx="281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ystemic leav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9234200">
              <a:off x="781920" y="4212720"/>
              <a:ext cx="668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9234200">
              <a:off x="1308960" y="4239720"/>
              <a:ext cx="581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V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9234200">
              <a:off x="1875600" y="4279320"/>
              <a:ext cx="457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7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9234200">
              <a:off x="2392920" y="4279320"/>
              <a:ext cx="457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9234200">
              <a:off x="2905920" y="4255200"/>
              <a:ext cx="533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9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9234200">
              <a:off x="4201200" y="4255560"/>
              <a:ext cx="533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9234200">
              <a:off x="4687200" y="4215960"/>
              <a:ext cx="653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7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9234200">
              <a:off x="5230080" y="4227120"/>
              <a:ext cx="618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9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9234200">
              <a:off x="5788800" y="4271760"/>
              <a:ext cx="482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9234200">
              <a:off x="3680640" y="4222080"/>
              <a:ext cx="639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9234200">
              <a:off x="3409200" y="4206240"/>
              <a:ext cx="687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9234200">
              <a:off x="3921840" y="4203000"/>
              <a:ext cx="695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V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9234200">
              <a:off x="4404600" y="4133520"/>
              <a:ext cx="914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7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9234200">
              <a:off x="5010840" y="4279320"/>
              <a:ext cx="457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9234200">
              <a:off x="5509440" y="4255200"/>
              <a:ext cx="533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9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975280" y="4667400"/>
              <a:ext cx="838440" cy="294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4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PVX C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4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antis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975280" y="492588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oad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47680" y="4479840"/>
              <a:ext cx="609480" cy="47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34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26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"/>
          <p:cNvGrpSpPr/>
          <p:nvPr/>
        </p:nvGrpSpPr>
        <p:grpSpPr>
          <a:xfrm>
            <a:off x="1468440" y="7364520"/>
            <a:ext cx="3994200" cy="1131840"/>
            <a:chOff x="1468440" y="7364520"/>
            <a:chExt cx="3994200" cy="1131840"/>
          </a:xfrm>
        </p:grpSpPr>
        <p:sp>
          <p:nvSpPr>
            <p:cNvPr id="76" name=""/>
            <p:cNvSpPr/>
            <p:nvPr/>
          </p:nvSpPr>
          <p:spPr>
            <a:xfrm>
              <a:off x="4799160" y="8126280"/>
              <a:ext cx="108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7" name="" descr=""/>
            <p:cNvPicPr/>
            <p:nvPr/>
          </p:nvPicPr>
          <p:blipFill>
            <a:blip r:embed="rId5">
              <a:lum bright="12000"/>
            </a:blip>
            <a:stretch/>
          </p:blipFill>
          <p:spPr>
            <a:xfrm>
              <a:off x="2205000" y="8018280"/>
              <a:ext cx="2590920" cy="2584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78" name="" descr=""/>
            <p:cNvPicPr/>
            <p:nvPr/>
          </p:nvPicPr>
          <p:blipFill>
            <a:blip r:embed="rId6">
              <a:lum bright="12000"/>
            </a:blip>
            <a:stretch/>
          </p:blipFill>
          <p:spPr>
            <a:xfrm>
              <a:off x="2205000" y="8280000"/>
              <a:ext cx="2590920" cy="1285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79" name=""/>
            <p:cNvSpPr/>
            <p:nvPr/>
          </p:nvSpPr>
          <p:spPr>
            <a:xfrm>
              <a:off x="2233800" y="7638840"/>
              <a:ext cx="2519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079720" y="7364520"/>
              <a:ext cx="281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ystemic leav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rot="19234200">
              <a:off x="2507400" y="7705080"/>
              <a:ext cx="533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9234200">
              <a:off x="3079080" y="7666920"/>
              <a:ext cx="653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7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9234200">
              <a:off x="3621960" y="7677720"/>
              <a:ext cx="619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9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9234200">
              <a:off x="4209120" y="7720920"/>
              <a:ext cx="482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9234200">
              <a:off x="4426920" y="7657200"/>
              <a:ext cx="687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rot="19234200">
              <a:off x="2133000" y="7654320"/>
              <a:ext cx="695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V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9234200">
              <a:off x="2783520" y="7682400"/>
              <a:ext cx="60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7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9234200">
              <a:off x="3374280" y="7728480"/>
              <a:ext cx="457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9234200">
              <a:off x="3901320" y="7705080"/>
              <a:ext cx="533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9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468440" y="8040600"/>
              <a:ext cx="83844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4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PVX C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antis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468440" y="825012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oad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853160" y="7929360"/>
              <a:ext cx="609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34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"/>
          <p:cNvSpPr/>
          <p:nvPr/>
        </p:nvSpPr>
        <p:spPr>
          <a:xfrm>
            <a:off x="5877000" y="3492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cc"/>
                </a:solidFill>
                <a:latin typeface="Times New Roman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765000" y="46836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765000" y="545940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"/>
          <p:cNvGrpSpPr/>
          <p:nvPr/>
        </p:nvGrpSpPr>
        <p:grpSpPr>
          <a:xfrm>
            <a:off x="1628640" y="525600"/>
            <a:ext cx="4518000" cy="3286080"/>
            <a:chOff x="1628640" y="525600"/>
            <a:chExt cx="4518000" cy="3286080"/>
          </a:xfrm>
        </p:grpSpPr>
        <p:pic>
          <p:nvPicPr>
            <p:cNvPr id="97" name="" descr=""/>
            <p:cNvPicPr/>
            <p:nvPr/>
          </p:nvPicPr>
          <p:blipFill>
            <a:blip r:embed="rId7"/>
            <a:stretch/>
          </p:blipFill>
          <p:spPr>
            <a:xfrm>
              <a:off x="1889280" y="766800"/>
              <a:ext cx="96012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98" name=""/>
            <p:cNvSpPr/>
            <p:nvPr/>
          </p:nvSpPr>
          <p:spPr>
            <a:xfrm>
              <a:off x="1801800" y="727200"/>
              <a:ext cx="50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" descr=""/>
            <p:cNvPicPr/>
            <p:nvPr/>
          </p:nvPicPr>
          <p:blipFill>
            <a:blip r:embed="rId8"/>
            <a:stretch/>
          </p:blipFill>
          <p:spPr>
            <a:xfrm>
              <a:off x="2890800" y="2313000"/>
              <a:ext cx="576360" cy="7192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00" name="" descr=""/>
            <p:cNvPicPr/>
            <p:nvPr/>
          </p:nvPicPr>
          <p:blipFill>
            <a:blip r:embed="rId9"/>
            <a:stretch/>
          </p:blipFill>
          <p:spPr>
            <a:xfrm>
              <a:off x="1889280" y="2313000"/>
              <a:ext cx="96012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01" name=""/>
            <p:cNvSpPr/>
            <p:nvPr/>
          </p:nvSpPr>
          <p:spPr>
            <a:xfrm>
              <a:off x="1801800" y="2273400"/>
              <a:ext cx="61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2" name="" descr=""/>
            <p:cNvPicPr/>
            <p:nvPr/>
          </p:nvPicPr>
          <p:blipFill>
            <a:blip r:embed="rId10"/>
            <a:stretch/>
          </p:blipFill>
          <p:spPr>
            <a:xfrm>
              <a:off x="4522680" y="3090960"/>
              <a:ext cx="576360" cy="7189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03" name="" descr=""/>
            <p:cNvPicPr/>
            <p:nvPr/>
          </p:nvPicPr>
          <p:blipFill>
            <a:blip r:embed="rId11"/>
            <a:stretch/>
          </p:blipFill>
          <p:spPr>
            <a:xfrm>
              <a:off x="3513240" y="309096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04" name=""/>
            <p:cNvSpPr/>
            <p:nvPr/>
          </p:nvSpPr>
          <p:spPr>
            <a:xfrm>
              <a:off x="3441600" y="3051000"/>
              <a:ext cx="636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5" name="" descr=""/>
            <p:cNvPicPr/>
            <p:nvPr/>
          </p:nvPicPr>
          <p:blipFill>
            <a:blip r:embed="rId12"/>
            <a:stretch/>
          </p:blipFill>
          <p:spPr>
            <a:xfrm>
              <a:off x="2887560" y="3090960"/>
              <a:ext cx="576360" cy="7189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06" name="" descr=""/>
            <p:cNvPicPr/>
            <p:nvPr/>
          </p:nvPicPr>
          <p:blipFill>
            <a:blip r:embed="rId13"/>
            <a:stretch/>
          </p:blipFill>
          <p:spPr>
            <a:xfrm>
              <a:off x="1889280" y="3090960"/>
              <a:ext cx="96012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07" name=""/>
            <p:cNvSpPr/>
            <p:nvPr/>
          </p:nvSpPr>
          <p:spPr>
            <a:xfrm>
              <a:off x="1801800" y="3051000"/>
              <a:ext cx="763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9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8" name="" descr=""/>
            <p:cNvPicPr/>
            <p:nvPr/>
          </p:nvPicPr>
          <p:blipFill>
            <a:blip r:embed="rId14"/>
            <a:stretch/>
          </p:blipFill>
          <p:spPr>
            <a:xfrm>
              <a:off x="4522680" y="2313000"/>
              <a:ext cx="576360" cy="7192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09" name="" descr=""/>
            <p:cNvPicPr/>
            <p:nvPr/>
          </p:nvPicPr>
          <p:blipFill>
            <a:blip r:embed="rId15"/>
            <a:stretch/>
          </p:blipFill>
          <p:spPr>
            <a:xfrm>
              <a:off x="3513240" y="231300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10" name=""/>
            <p:cNvSpPr/>
            <p:nvPr/>
          </p:nvSpPr>
          <p:spPr>
            <a:xfrm>
              <a:off x="3441600" y="2273400"/>
              <a:ext cx="70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9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1" name="" descr=""/>
            <p:cNvPicPr/>
            <p:nvPr/>
          </p:nvPicPr>
          <p:blipFill>
            <a:blip r:embed="rId16"/>
            <a:stretch/>
          </p:blipFill>
          <p:spPr>
            <a:xfrm>
              <a:off x="4522680" y="1535040"/>
              <a:ext cx="576360" cy="7192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12" name="" descr=""/>
            <p:cNvPicPr/>
            <p:nvPr/>
          </p:nvPicPr>
          <p:blipFill>
            <a:blip r:embed="rId17"/>
            <a:stretch/>
          </p:blipFill>
          <p:spPr>
            <a:xfrm>
              <a:off x="3513240" y="153504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13" name=""/>
            <p:cNvSpPr/>
            <p:nvPr/>
          </p:nvSpPr>
          <p:spPr>
            <a:xfrm>
              <a:off x="3441600" y="1495440"/>
              <a:ext cx="779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7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4" name="" descr=""/>
            <p:cNvPicPr/>
            <p:nvPr/>
          </p:nvPicPr>
          <p:blipFill>
            <a:blip r:embed="rId18"/>
            <a:stretch/>
          </p:blipFill>
          <p:spPr>
            <a:xfrm>
              <a:off x="2887560" y="1535040"/>
              <a:ext cx="576360" cy="7192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15" name="" descr=""/>
            <p:cNvPicPr/>
            <p:nvPr/>
          </p:nvPicPr>
          <p:blipFill>
            <a:blip r:embed="rId19"/>
            <a:stretch/>
          </p:blipFill>
          <p:spPr>
            <a:xfrm>
              <a:off x="1889280" y="1535040"/>
              <a:ext cx="96012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16" name=""/>
            <p:cNvSpPr/>
            <p:nvPr/>
          </p:nvSpPr>
          <p:spPr>
            <a:xfrm>
              <a:off x="1801800" y="1495440"/>
              <a:ext cx="690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7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7" name="" descr=""/>
            <p:cNvPicPr/>
            <p:nvPr/>
          </p:nvPicPr>
          <p:blipFill>
            <a:blip r:embed="rId20"/>
            <a:stretch/>
          </p:blipFill>
          <p:spPr>
            <a:xfrm>
              <a:off x="4522680" y="766800"/>
              <a:ext cx="576360" cy="7192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18" name="" descr=""/>
            <p:cNvPicPr/>
            <p:nvPr/>
          </p:nvPicPr>
          <p:blipFill>
            <a:blip r:embed="rId21"/>
            <a:stretch/>
          </p:blipFill>
          <p:spPr>
            <a:xfrm>
              <a:off x="3513240" y="76680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19" name=""/>
            <p:cNvSpPr/>
            <p:nvPr/>
          </p:nvSpPr>
          <p:spPr>
            <a:xfrm>
              <a:off x="3441600" y="727200"/>
              <a:ext cx="636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0" name="" descr=""/>
            <p:cNvPicPr/>
            <p:nvPr/>
          </p:nvPicPr>
          <p:blipFill>
            <a:blip r:embed="rId22"/>
            <a:stretch/>
          </p:blipFill>
          <p:spPr>
            <a:xfrm>
              <a:off x="2890800" y="766800"/>
              <a:ext cx="576360" cy="71928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21" name=""/>
            <p:cNvSpPr/>
            <p:nvPr/>
          </p:nvSpPr>
          <p:spPr>
            <a:xfrm>
              <a:off x="1628640" y="525600"/>
              <a:ext cx="4518000" cy="30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N. Benthamiana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 leaves infiltrated with chimaeric PVX vectors   ( 7 dp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"/>
          <p:cNvGrpSpPr/>
          <p:nvPr/>
        </p:nvGrpSpPr>
        <p:grpSpPr>
          <a:xfrm>
            <a:off x="1357200" y="5562720"/>
            <a:ext cx="4681800" cy="1728720"/>
            <a:chOff x="1357200" y="5562720"/>
            <a:chExt cx="4681800" cy="1728720"/>
          </a:xfrm>
        </p:grpSpPr>
        <p:pic>
          <p:nvPicPr>
            <p:cNvPr id="123" name="" descr=""/>
            <p:cNvPicPr/>
            <p:nvPr/>
          </p:nvPicPr>
          <p:blipFill>
            <a:blip r:embed="rId23">
              <a:lum bright="-12000"/>
            </a:blip>
            <a:stretch/>
          </p:blipFill>
          <p:spPr>
            <a:xfrm>
              <a:off x="4540320" y="657072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24" name="" descr=""/>
            <p:cNvPicPr/>
            <p:nvPr/>
          </p:nvPicPr>
          <p:blipFill>
            <a:blip r:embed="rId24">
              <a:lum bright="-6000"/>
            </a:blip>
            <a:stretch/>
          </p:blipFill>
          <p:spPr>
            <a:xfrm>
              <a:off x="1500120" y="581364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25" name="" descr=""/>
            <p:cNvPicPr/>
            <p:nvPr/>
          </p:nvPicPr>
          <p:blipFill>
            <a:blip r:embed="rId25">
              <a:lum bright="-6000"/>
            </a:blip>
            <a:stretch/>
          </p:blipFill>
          <p:spPr>
            <a:xfrm>
              <a:off x="2514600" y="581364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26" name="" descr=""/>
            <p:cNvPicPr/>
            <p:nvPr/>
          </p:nvPicPr>
          <p:blipFill>
            <a:blip r:embed="rId26">
              <a:lum bright="-6000"/>
            </a:blip>
            <a:stretch/>
          </p:blipFill>
          <p:spPr>
            <a:xfrm>
              <a:off x="3525840" y="581364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27" name="" descr=""/>
            <p:cNvPicPr/>
            <p:nvPr/>
          </p:nvPicPr>
          <p:blipFill>
            <a:blip r:embed="rId27">
              <a:lum bright="-6000"/>
            </a:blip>
            <a:stretch/>
          </p:blipFill>
          <p:spPr>
            <a:xfrm>
              <a:off x="4540320" y="581364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28" name="" descr=""/>
            <p:cNvPicPr/>
            <p:nvPr/>
          </p:nvPicPr>
          <p:blipFill>
            <a:blip r:embed="rId28">
              <a:lum bright="-6000"/>
            </a:blip>
            <a:stretch/>
          </p:blipFill>
          <p:spPr>
            <a:xfrm>
              <a:off x="1500120" y="657072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29" name="" descr=""/>
            <p:cNvPicPr/>
            <p:nvPr/>
          </p:nvPicPr>
          <p:blipFill>
            <a:blip r:embed="rId29">
              <a:lum bright="-6000"/>
            </a:blip>
            <a:stretch/>
          </p:blipFill>
          <p:spPr>
            <a:xfrm>
              <a:off x="2514600" y="657072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pic>
          <p:nvPicPr>
            <p:cNvPr id="130" name="" descr=""/>
            <p:cNvPicPr/>
            <p:nvPr/>
          </p:nvPicPr>
          <p:blipFill>
            <a:blip r:embed="rId30">
              <a:lum bright="-6000"/>
            </a:blip>
            <a:stretch/>
          </p:blipFill>
          <p:spPr>
            <a:xfrm>
              <a:off x="3525840" y="6570720"/>
              <a:ext cx="960480" cy="720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131" name=""/>
            <p:cNvSpPr/>
            <p:nvPr/>
          </p:nvSpPr>
          <p:spPr>
            <a:xfrm>
              <a:off x="1430280" y="5781600"/>
              <a:ext cx="73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465800" y="5781600"/>
              <a:ext cx="75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7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444840" y="5781600"/>
              <a:ext cx="73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7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435400" y="5781600"/>
              <a:ext cx="60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430280" y="6540480"/>
              <a:ext cx="609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465800" y="6540480"/>
              <a:ext cx="60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3444840" y="6540480"/>
              <a:ext cx="73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9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435400" y="6540480"/>
              <a:ext cx="71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VX-S9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357200" y="5562720"/>
              <a:ext cx="4681800" cy="30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zh-CN" sz="1000" spc="-1" strike="noStrike">
                  <a:solidFill>
                    <a:srgbClr val="000000"/>
                  </a:solidFill>
                  <a:latin typeface="Arial"/>
                </a:rPr>
                <a:t>N. Benthamiana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 leaves infiltrated with chimaeric PVX vectors      (15 dp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1T07:05:39Z</dcterms:created>
  <dc:creator>MC SYSTEM</dc:creator>
  <dc:description/>
  <dc:language>en-US</dc:language>
  <cp:lastModifiedBy>MC SYSTEM</cp:lastModifiedBy>
  <dcterms:modified xsi:type="dcterms:W3CDTF">2013-10-23T01:24:52Z</dcterms:modified>
  <cp:revision>10</cp:revision>
  <dc:subject/>
  <dc:title>幻灯片 1</dc:title>
</cp:coreProperties>
</file>